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8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AA0CCB7-7545-4CD7-BFCE-2B5BBA77656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8706134-9356-470C-BE08-08EB670F27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DE8A540-4621-40C5-AD58-5899A99A49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E839B-2B9C-4180-834F-1B23F64321A1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34262E3-D3D9-4CEA-A165-EE3373BC5A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E8C63D4-42FA-48A0-9AFE-1B2261893B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458E7-ECE8-4E7F-AC55-BF74C4D0F6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182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2E35A48-3A5D-43AA-AD11-D68A30976E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DF76AA6-40F8-40DC-9BED-49FA26018A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8708A22-DA4E-4F75-A834-AD786F1BAC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E839B-2B9C-4180-834F-1B23F64321A1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3DD85F6-BEFE-4185-AFBF-0894B24A8A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CE8F948-6BBB-4F28-BDB0-FEF007379E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458E7-ECE8-4E7F-AC55-BF74C4D0F6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94215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F6A8CA9-2DBA-42AF-ACB0-C416B29EF35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F8C7CAE-1FC7-48B8-84B7-445D298E74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E5EC561-8CCB-4F09-906F-3AA81E9DD2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E839B-2B9C-4180-834F-1B23F64321A1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5CF08ED-2EC4-4565-BDDD-A64716C56B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CA719C0-0011-4899-9B82-8FC231E972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458E7-ECE8-4E7F-AC55-BF74C4D0F6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52203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F1EB00B-3642-49C1-8CDE-879A2EE171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F02E4E7-B2C5-4993-A738-3D431AE5335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E5DD921-F6CD-4BD0-BACC-4265BE158C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E839B-2B9C-4180-834F-1B23F64321A1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BA274A4-0265-49C6-B2E9-A94D92BF0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054F32B-AE94-4625-A1BF-D417778C14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458E7-ECE8-4E7F-AC55-BF74C4D0F6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19235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53BE78-E7AA-445D-8A6D-AAC7308E42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5827939-6393-4B3C-B90B-7298605BC8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81D296-B884-41DC-80CE-5ED3D6D399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E839B-2B9C-4180-834F-1B23F64321A1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12F1556-08FD-4915-A2FD-1FB9FBF74D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C1E4575-B977-41D1-8F6A-3A354E8043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458E7-ECE8-4E7F-AC55-BF74C4D0F6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92003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79FC7B4-D353-4370-A145-EF7AD78533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45E75EA-CAFD-4A0A-A2CD-4E540EEAC8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824FF82-29A0-45D1-BACA-98A86A2E09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1D3E011-EA6A-4F84-8225-280E2256EC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E839B-2B9C-4180-834F-1B23F64321A1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F62DBCF-34E4-4ED1-9900-DA35A42ABB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697D9AB-C9FA-4C02-A1BA-C4E3AC0723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458E7-ECE8-4E7F-AC55-BF74C4D0F6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68083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CBF02FC-ABFD-4F32-BB65-DC9A2A050C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F8436D0-7B8D-479D-B731-0F156EFFCF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12B7BF9-54A6-4D88-B921-2D7086D730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7FC6F44-A16C-4DF7-B893-BC81CCF0949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88EEADA-28AE-4DD0-AFD8-7AA90695117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76A7328-9236-4847-AF09-22CBD49E83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E839B-2B9C-4180-834F-1B23F64321A1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4709098-5245-4E23-866C-8B430ABDEF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0D8F983-6119-4567-A230-F3D835EA4D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458E7-ECE8-4E7F-AC55-BF74C4D0F6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6582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CBFB186-9B62-4FAC-8279-D07DC125D6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13FFF60-C58C-4014-94B1-9BBF5D3933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E839B-2B9C-4180-834F-1B23F64321A1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B740426-6DC0-4FCF-BD0D-A47075657C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CDA739D-4370-4E6C-B89B-766748E67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458E7-ECE8-4E7F-AC55-BF74C4D0F6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75671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9CA19FB-BE8B-4789-9D64-96D88CB299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E839B-2B9C-4180-834F-1B23F64321A1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683EAE9-840F-4A03-962B-5F92045E7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B57A1C38-CA7E-4D3D-A872-431308F1D4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458E7-ECE8-4E7F-AC55-BF74C4D0F6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18176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D4F1AC4-07F1-4A04-963C-116CFC595C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6B865EE-E8AB-4094-94D4-DB36185F32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1030A67-94DC-4D37-8BA1-2F42C5EB38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DBA935A-18E2-4F5C-B542-2437D3145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E839B-2B9C-4180-834F-1B23F64321A1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5E9C88B-7BD4-491A-9E68-92C98106D8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D6F63CD-A622-4DB6-A9D2-751CB1D568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458E7-ECE8-4E7F-AC55-BF74C4D0F6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7687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DC2424-E15C-4854-A9E8-3182A8F390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C1E536D-5BFA-4AC7-8867-A9FE24DCB63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BB2ADF4-8835-4A29-862D-EF5180413D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E380852-01F6-4470-A168-823F1B646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E839B-2B9C-4180-834F-1B23F64321A1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F480B27-1083-4C4F-9C0D-3B54490E90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2BBE775-C88B-4AFB-9BEA-1B664AA4C1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458E7-ECE8-4E7F-AC55-BF74C4D0F6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65394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0514088-A816-455D-BDE9-06B2B3AB89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450CB8F-B1D9-4233-8481-B414ED4A1C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9EE2529-A64B-4E0A-B9F9-ADEF783DEC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DE839B-2B9C-4180-834F-1B23F64321A1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F4723D1-361E-4D33-97D4-F17CDBA1F4B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D83CBF2-FDDF-4E63-AC46-BB163299DC2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0458E7-ECE8-4E7F-AC55-BF74C4D0F6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62787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22AFB03E-A9A3-4478-804F-EB10FCA3FFC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1550" y="938292"/>
            <a:ext cx="6902196" cy="3446231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79D5D27D-8609-48BD-901E-84C057A1019B}"/>
              </a:ext>
            </a:extLst>
          </p:cNvPr>
          <p:cNvSpPr txBox="1"/>
          <p:nvPr/>
        </p:nvSpPr>
        <p:spPr>
          <a:xfrm>
            <a:off x="629920" y="568960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C76E3180-2683-4BA7-85BE-38A10E2B73CB}"/>
              </a:ext>
            </a:extLst>
          </p:cNvPr>
          <p:cNvSpPr txBox="1"/>
          <p:nvPr/>
        </p:nvSpPr>
        <p:spPr>
          <a:xfrm>
            <a:off x="1731550" y="4379926"/>
            <a:ext cx="782901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1. Loss of ANGPTL3 expression in the kidneys of mice after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angptl3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knockout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04576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2B394513-487A-4E86-9595-2D0CBDFAA54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890" y="868323"/>
            <a:ext cx="4320000" cy="3515676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C27A60F2-4E06-45DC-B7E3-520C85384E9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6560" y="1192784"/>
            <a:ext cx="4320000" cy="248547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1301EC2A-63FC-4C7C-B918-22D2567AFE2B}"/>
              </a:ext>
            </a:extLst>
          </p:cNvPr>
          <p:cNvSpPr txBox="1"/>
          <p:nvPr/>
        </p:nvSpPr>
        <p:spPr>
          <a:xfrm>
            <a:off x="447040" y="264160"/>
            <a:ext cx="13908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40130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21</Words>
  <Application>Microsoft Office PowerPoint</Application>
  <PresentationFormat>宽屏</PresentationFormat>
  <Paragraphs>3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uany</dc:creator>
  <cp:lastModifiedBy>guany</cp:lastModifiedBy>
  <cp:revision>17</cp:revision>
  <dcterms:created xsi:type="dcterms:W3CDTF">2022-08-16T15:23:58Z</dcterms:created>
  <dcterms:modified xsi:type="dcterms:W3CDTF">2022-08-18T02:40:13Z</dcterms:modified>
</cp:coreProperties>
</file>